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D1A046-C844-4019-A57F-8467A884C9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7A725-D000-42EA-868B-635F067D08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4E655-244F-4D6A-8DF1-F29CBB051B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24586-208B-4B15-8096-6688266603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51001-5347-455B-9AEA-F5E5077E65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FC73B-E15A-4257-8D11-7A44DEB3AB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8F82D-8E04-4163-B65D-A3B41427CC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E8A75-DE42-46C1-A075-91DA593348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E8B4C-9CA6-4F06-88B2-38B770BC09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D14AF-B0CD-4018-A31E-3AC3E32089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0D043-23B2-4C62-8DBF-192D3CE0D0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BCE03-21E1-4955-9EB6-78C25223F9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AAFFA8-13E5-4D4B-971B-589103FF9059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2197080" y="44280"/>
            <a:ext cx="5327640" cy="6070680"/>
          </a:xfrm>
          <a:prstGeom prst="rect">
            <a:avLst/>
          </a:prstGeom>
          <a:ln w="0">
            <a:noFill/>
          </a:ln>
        </p:spPr>
      </p:pic>
      <p:sp>
        <p:nvSpPr>
          <p:cNvPr id="42" name="Text Box 3"/>
          <p:cNvSpPr/>
          <p:nvPr/>
        </p:nvSpPr>
        <p:spPr>
          <a:xfrm>
            <a:off x="2411280" y="6165720"/>
            <a:ext cx="5545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Figure S2. Double-color FISH showing the six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lgbp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containing BACs co-localized at the same site of th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C. farreri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genome [21]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7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4T17:48:13Z</dcterms:created>
  <dc:creator>xjzhang</dc:creator>
  <dc:description/>
  <cp:keywords/>
  <dc:language>en-US</dc:language>
  <cp:lastModifiedBy>雨林木风</cp:lastModifiedBy>
  <cp:lastPrinted>1899-12-30T00:00:00Z</cp:lastPrinted>
  <dcterms:modified xsi:type="dcterms:W3CDTF">2011-10-10T12:54:23Z</dcterms:modified>
  <cp:revision>10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6.0.2699</vt:lpwstr>
  </property>
</Properties>
</file>